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05842-BC28-4F23-9297-057FA181BB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F9D90-5F87-4D82-A7C5-1BA6C1EEAB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F8E2E-D5D8-4027-95AA-DB1402FC08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242B9A-9037-4F4C-8356-F22176B5FF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42777-9B87-4DD8-8DA1-29989F0751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9D727-4C65-4F19-9FD4-E4A931FA68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B8335-DCD5-43D9-B3E1-5398605D3F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0D579-BB7C-4713-A5FE-EF9B0A19B4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4D110-4BD4-465A-B30F-5DE3E51707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636C70-26E6-4CB1-95D8-0FDAE25D3F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01C41-E880-40DF-981E-C99AF5ABE6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A3B36-6CE3-4546-B9DF-3D8DE3E703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E3D6D6-4055-44A3-980A-84D6C2C6BC4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9"/>
          <p:cNvSpPr/>
          <p:nvPr/>
        </p:nvSpPr>
        <p:spPr>
          <a:xfrm>
            <a:off x="485640" y="14256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"/>
          <p:cNvSpPr/>
          <p:nvPr/>
        </p:nvSpPr>
        <p:spPr>
          <a:xfrm>
            <a:off x="0" y="6248520"/>
            <a:ext cx="914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Figure S1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Risk of bias summary for each included study about intrauterine (a) and extrauterine prevention 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8" descr=""/>
          <p:cNvPicPr/>
          <p:nvPr/>
        </p:nvPicPr>
        <p:blipFill>
          <a:blip r:embed="rId1"/>
          <a:stretch/>
        </p:blipFill>
        <p:spPr>
          <a:xfrm>
            <a:off x="0" y="380880"/>
            <a:ext cx="9144000" cy="24973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"/>
          <p:cNvPicPr/>
          <p:nvPr/>
        </p:nvPicPr>
        <p:blipFill>
          <a:blip r:embed="rId2"/>
          <a:stretch/>
        </p:blipFill>
        <p:spPr>
          <a:xfrm>
            <a:off x="685800" y="2971800"/>
            <a:ext cx="7543800" cy="3133800"/>
          </a:xfrm>
          <a:prstGeom prst="rect">
            <a:avLst/>
          </a:prstGeom>
          <a:ln w="0">
            <a:noFill/>
          </a:ln>
        </p:spPr>
      </p:pic>
      <p:sp>
        <p:nvSpPr>
          <p:cNvPr id="45" name="TextBox 5"/>
          <p:cNvSpPr/>
          <p:nvPr/>
        </p:nvSpPr>
        <p:spPr>
          <a:xfrm>
            <a:off x="7467480" y="45720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6"/>
          <p:cNvSpPr/>
          <p:nvPr/>
        </p:nvSpPr>
        <p:spPr>
          <a:xfrm>
            <a:off x="7543800" y="320040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ell</cp:lastModifiedBy>
  <dcterms:modified xsi:type="dcterms:W3CDTF">2012-05-19T15:43:15Z</dcterms:modified>
  <cp:revision>1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